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28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64" y="1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913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9345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9430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5677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0473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4907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6885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0619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4856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1779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561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B31CDF-76B7-488B-8514-EE3CB6F6C44E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9CB015-3E1B-407E-ABAF-7CCB17CA0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3526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EBD10B29-0C62-42CC-98E0-1EDB70CDBA3B}"/>
              </a:ext>
            </a:extLst>
          </p:cNvPr>
          <p:cNvSpPr txBox="1"/>
          <p:nvPr/>
        </p:nvSpPr>
        <p:spPr>
          <a:xfrm>
            <a:off x="354051" y="347236"/>
            <a:ext cx="6149898" cy="1167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ure S5.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We counted three bitter pit cells and measured 6 large starch granules and 6 small starch granules in each cell. Each starch granule was cross measured twice, and the average value was taken as the size of a starch granule. Data are means ± standard error (SE). LSG, large starch granule; SSG, small starch granule.</a:t>
            </a:r>
            <a:endParaRPr lang="zh-CN" altLang="zh-C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7" name="图片 6" descr="图片包含 形状&#10;&#10;描述已自动生成">
            <a:extLst>
              <a:ext uri="{FF2B5EF4-FFF2-40B4-BE49-F238E27FC236}">
                <a16:creationId xmlns:a16="http://schemas.microsoft.com/office/drawing/2014/main" id="{77A57BE1-005F-405A-A052-83EE127736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8612" y="2139660"/>
            <a:ext cx="3389376" cy="2916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86150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68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u haiyong</dc:creator>
  <cp:lastModifiedBy>qu haiyong</cp:lastModifiedBy>
  <cp:revision>3</cp:revision>
  <dcterms:created xsi:type="dcterms:W3CDTF">2021-08-21T04:01:33Z</dcterms:created>
  <dcterms:modified xsi:type="dcterms:W3CDTF">2021-08-21T17:53:51Z</dcterms:modified>
</cp:coreProperties>
</file>